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B5E1ED-3A6B-305E-1C1D-3478D3338C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DA555B-C8F2-3AC1-9B41-2FE4CD4BEF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A03E18-6D7F-D371-88C6-CB77460ED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EA62EE-F76E-220D-27CF-991F1EABA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FC03D-264E-AB76-4C3D-FFC648649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438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EAD856-B635-2935-F280-0A9600BEDF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9883A0-EE49-E66D-B659-7EEAE2631E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1258DA-F0DF-3C9A-6E06-BBE3722B1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CCB8FD-6E6B-B151-9236-6E095ABAE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67E586-58A9-88CE-7DE5-74F747D1A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0866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0004893-AEA6-D9B5-743C-8134325178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E8B1B9-805F-2469-5BDE-B6386BAF20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6AD294-9555-9440-5569-F7A2C60CE9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13F7D-AD7F-EA26-8645-7A2ECA00F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EE3A34-FD88-9951-7400-2877D264C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5625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76B449-8A4D-CCD6-9C61-D86C30D8B5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8B0F38-F06D-C1B2-411A-57AED69C81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2CF27-4F82-DD0F-C7AD-DBFC70EAE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07DE84-8DB6-4519-F5B9-51291D2B9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10289E-3709-F9B8-19CC-BE171414D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6925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3998FF-69A7-3C0E-6170-005DFDBC5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631F41-4DC8-BC26-33E1-F6E60FAE7D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1B3CD7-2E5E-C70B-0D9B-3D8B0F4DA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4459EB-E4AB-3B2E-E622-13CE27CB3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0B10A8-C5BC-37AB-2EEB-41C6C4912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232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9F633-6B86-4CD0-F818-EB2606D245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733642-4039-72E2-10D4-0F9E496204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41F8D8-D098-FC93-4CB6-0DBB0BB1BB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636D30-D3A6-1AE8-7140-17531BAC3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7A93E0-837E-B905-F297-06AA9D4E9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3FC576-7111-A37B-7F5D-97A3A04CD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6339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73F8D8-CB6D-D43F-8D86-687481AC7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DC9441-FE0E-83F0-E384-35944A19F5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79E23F-BB73-BE62-6310-41B9527DDC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EAF05E-6054-19AC-FAD5-AEED46A9CE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B7C715-5E55-85F8-DD93-6FAB149975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69D3B7-0C72-2EC1-185D-7018BE87C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0ECAC12-8BFC-880D-55B1-BE0143000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4FD8CB-3A23-EFF4-7F45-64EEC1EC4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8325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46F01D-B149-4BDA-3A43-752CD225EE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00949B-CAC6-D0A7-A718-97EA1BA81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E16AF2-3671-6B19-2791-83E70D94C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3E8BEC-9793-8224-6542-70DA28017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3368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C3F0C1-9DAD-7317-189C-20558D722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FFA4E1-4AB4-A05F-EA14-9BD7361B3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322005-B0DD-CF7C-AAFF-86F18761D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6214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9D0D88-6FBC-37E4-A2F2-35B0BF7D2B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EA8955-A425-994C-9A14-0591E7DD0F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CDF700-6686-1936-816D-E865B8C126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DC6F49-F2F8-CF07-79E5-D940BF8EC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F46E23-E3BF-9065-3A07-FB2A2654B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2F14E2-0C36-0A64-4854-0BBFD9911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4810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EEEBF3-AC5A-CC36-F8FA-18608816B3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FAF7F1-9015-3857-A378-CAD4D36F50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26C074-0D6C-9BF4-2DA2-8D5620CB39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92C74B-0D06-E8D8-931E-B0F2A845C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777B2A-4950-6901-2F34-9B8D7789C5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E3EE92-1EAE-4F42-3949-D3D3B175A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3537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F17703-EF16-0A57-9D28-865BC376FC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0599EE-F48E-8692-549B-FB6EACA127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8C1382-64B4-99B7-3864-52F5EE9304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46181-ACD8-44EE-84FC-768B23BA9E1E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C500C8-F443-5985-CBA5-E69CD8E70A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5B4593-ACC1-FD5C-DAE0-7751404EAB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F7A14-18C4-451B-BBC9-40C4C4DEC7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2979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687514A-E647-2443-0DE9-0F1C06AC24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6112" y="336429"/>
            <a:ext cx="3016229" cy="643584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8E90EC9-A07C-D158-9CE2-8097083CC3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01575" y="2365733"/>
            <a:ext cx="3124200" cy="24765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EDA7B30-61B4-9CA7-E7C1-0A250D1FD698}"/>
              </a:ext>
            </a:extLst>
          </p:cNvPr>
          <p:cNvSpPr txBox="1"/>
          <p:nvPr/>
        </p:nvSpPr>
        <p:spPr>
          <a:xfrm>
            <a:off x="2268798" y="2225084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EPHS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3C2B34-5357-E468-3CF6-B6869C02A248}"/>
              </a:ext>
            </a:extLst>
          </p:cNvPr>
          <p:cNvSpPr txBox="1"/>
          <p:nvPr/>
        </p:nvSpPr>
        <p:spPr>
          <a:xfrm>
            <a:off x="2221095" y="694309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incul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BAF040A-FB63-0223-D5FC-9F2B92A07329}"/>
              </a:ext>
            </a:extLst>
          </p:cNvPr>
          <p:cNvSpPr txBox="1"/>
          <p:nvPr/>
        </p:nvSpPr>
        <p:spPr>
          <a:xfrm>
            <a:off x="2320441" y="4143978"/>
            <a:ext cx="682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PX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F7B0848-6B8C-7E6B-8262-A05CB0079D88}"/>
              </a:ext>
            </a:extLst>
          </p:cNvPr>
          <p:cNvSpPr txBox="1"/>
          <p:nvPr/>
        </p:nvSpPr>
        <p:spPr>
          <a:xfrm rot="16200000">
            <a:off x="9219221" y="1460401"/>
            <a:ext cx="1608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 - Na2SeO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07973DB-B922-84C1-7833-B965212495A1}"/>
              </a:ext>
            </a:extLst>
          </p:cNvPr>
          <p:cNvSpPr txBox="1"/>
          <p:nvPr/>
        </p:nvSpPr>
        <p:spPr>
          <a:xfrm rot="16200000">
            <a:off x="8641589" y="1424342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 + Na2SeO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2DBCE7-7E8A-17AE-DDD4-40AA7021C308}"/>
              </a:ext>
            </a:extLst>
          </p:cNvPr>
          <p:cNvSpPr txBox="1"/>
          <p:nvPr/>
        </p:nvSpPr>
        <p:spPr>
          <a:xfrm rot="16200000">
            <a:off x="7295001" y="1154934"/>
            <a:ext cx="2253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gSEPSECS</a:t>
            </a:r>
            <a:r>
              <a:rPr lang="en-GB" dirty="0"/>
              <a:t> + Na2SeO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B73C9C5-D05D-D951-7167-0AC8F20DB28C}"/>
              </a:ext>
            </a:extLst>
          </p:cNvPr>
          <p:cNvSpPr txBox="1"/>
          <p:nvPr/>
        </p:nvSpPr>
        <p:spPr>
          <a:xfrm>
            <a:off x="7213190" y="2957975"/>
            <a:ext cx="888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EPH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B41AAF1-983A-58FF-7FAD-10D6440EF9F7}"/>
              </a:ext>
            </a:extLst>
          </p:cNvPr>
          <p:cNvSpPr txBox="1"/>
          <p:nvPr/>
        </p:nvSpPr>
        <p:spPr>
          <a:xfrm>
            <a:off x="2712991" y="380915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u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DBE6775-535D-5E23-69C3-118FFF295C4E}"/>
              </a:ext>
            </a:extLst>
          </p:cNvPr>
          <p:cNvSpPr txBox="1"/>
          <p:nvPr/>
        </p:nvSpPr>
        <p:spPr>
          <a:xfrm>
            <a:off x="2712991" y="172558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u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8E1BEFE-340A-1996-2875-E5943E330984}"/>
              </a:ext>
            </a:extLst>
          </p:cNvPr>
          <p:cNvSpPr txBox="1"/>
          <p:nvPr/>
        </p:nvSpPr>
        <p:spPr>
          <a:xfrm>
            <a:off x="8101575" y="5045698"/>
            <a:ext cx="238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arker exposure/imag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CCCDEF-0239-5E64-2510-67DB6AC6A47B}"/>
              </a:ext>
            </a:extLst>
          </p:cNvPr>
          <p:cNvSpPr txBox="1"/>
          <p:nvPr/>
        </p:nvSpPr>
        <p:spPr>
          <a:xfrm rot="16200000">
            <a:off x="7862470" y="1137286"/>
            <a:ext cx="2175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gSEPHS2 + Na2SeO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E790495-740A-9C5C-B188-0E9FEA0BE461}"/>
              </a:ext>
            </a:extLst>
          </p:cNvPr>
          <p:cNvSpPr txBox="1"/>
          <p:nvPr/>
        </p:nvSpPr>
        <p:spPr>
          <a:xfrm rot="16200000">
            <a:off x="4230277" y="5866565"/>
            <a:ext cx="1608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 - Na2SeO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E69F262-110D-B398-7892-66E43F32F50B}"/>
              </a:ext>
            </a:extLst>
          </p:cNvPr>
          <p:cNvSpPr txBox="1"/>
          <p:nvPr/>
        </p:nvSpPr>
        <p:spPr>
          <a:xfrm rot="16200000">
            <a:off x="3652645" y="5830506"/>
            <a:ext cx="1705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TC + Na2SeO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DBAD85F-A7F5-6C14-7ACD-3C073620E0BB}"/>
              </a:ext>
            </a:extLst>
          </p:cNvPr>
          <p:cNvSpPr txBox="1"/>
          <p:nvPr/>
        </p:nvSpPr>
        <p:spPr>
          <a:xfrm rot="16200000">
            <a:off x="2306057" y="5561098"/>
            <a:ext cx="2253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gSEPSECS</a:t>
            </a:r>
            <a:r>
              <a:rPr lang="en-GB" dirty="0"/>
              <a:t> + Na2SeO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B0C9596-EB12-59AA-F8BA-E85CF015D10E}"/>
              </a:ext>
            </a:extLst>
          </p:cNvPr>
          <p:cNvSpPr txBox="1"/>
          <p:nvPr/>
        </p:nvSpPr>
        <p:spPr>
          <a:xfrm rot="16200000">
            <a:off x="2873526" y="5543450"/>
            <a:ext cx="2175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gSEPHS2 + Na2SeO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7591414-D7C2-D705-9387-F8E45CD0E00D}"/>
              </a:ext>
            </a:extLst>
          </p:cNvPr>
          <p:cNvSpPr txBox="1"/>
          <p:nvPr/>
        </p:nvSpPr>
        <p:spPr>
          <a:xfrm>
            <a:off x="6076987" y="5543449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DBC7C4C-BE5B-CDB9-F49C-165A2DEF0D1D}"/>
              </a:ext>
            </a:extLst>
          </p:cNvPr>
          <p:cNvSpPr txBox="1"/>
          <p:nvPr/>
        </p:nvSpPr>
        <p:spPr>
          <a:xfrm>
            <a:off x="6026341" y="4619237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48B5977-88D3-5236-7634-D50DE513A696}"/>
              </a:ext>
            </a:extLst>
          </p:cNvPr>
          <p:cNvSpPr txBox="1"/>
          <p:nvPr/>
        </p:nvSpPr>
        <p:spPr>
          <a:xfrm>
            <a:off x="6031269" y="3879691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2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7B93459-64B0-806B-AA89-41B9CA58FDA5}"/>
              </a:ext>
            </a:extLst>
          </p:cNvPr>
          <p:cNvSpPr txBox="1"/>
          <p:nvPr/>
        </p:nvSpPr>
        <p:spPr>
          <a:xfrm>
            <a:off x="6026341" y="3401359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10E844F-32A1-2BC5-64D3-68E36C622EB9}"/>
              </a:ext>
            </a:extLst>
          </p:cNvPr>
          <p:cNvSpPr txBox="1"/>
          <p:nvPr/>
        </p:nvSpPr>
        <p:spPr>
          <a:xfrm>
            <a:off x="6026340" y="2793643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BD23D6B-C1AD-02E3-0B72-F6537878524A}"/>
              </a:ext>
            </a:extLst>
          </p:cNvPr>
          <p:cNvSpPr txBox="1"/>
          <p:nvPr/>
        </p:nvSpPr>
        <p:spPr>
          <a:xfrm>
            <a:off x="6031268" y="2357200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35CE80D-9BB5-EBDF-6497-7918DDDB7C1D}"/>
              </a:ext>
            </a:extLst>
          </p:cNvPr>
          <p:cNvSpPr txBox="1"/>
          <p:nvPr/>
        </p:nvSpPr>
        <p:spPr>
          <a:xfrm>
            <a:off x="5962783" y="1158310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0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A53FD1E-752F-372F-09FE-681CA07D21AF}"/>
              </a:ext>
            </a:extLst>
          </p:cNvPr>
          <p:cNvSpPr txBox="1"/>
          <p:nvPr/>
        </p:nvSpPr>
        <p:spPr>
          <a:xfrm>
            <a:off x="5962783" y="788096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3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95A56CE-9C71-7711-1EF5-CB5F0AC77DC5}"/>
              </a:ext>
            </a:extLst>
          </p:cNvPr>
          <p:cNvSpPr txBox="1"/>
          <p:nvPr/>
        </p:nvSpPr>
        <p:spPr>
          <a:xfrm>
            <a:off x="5971044" y="579410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8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2C18BFF-D92F-1040-4555-2D6122F78558}"/>
              </a:ext>
            </a:extLst>
          </p:cNvPr>
          <p:cNvSpPr txBox="1"/>
          <p:nvPr/>
        </p:nvSpPr>
        <p:spPr>
          <a:xfrm>
            <a:off x="10811238" y="4178482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E5E03AF-70F6-AA6F-2C6D-9541A0F530C7}"/>
              </a:ext>
            </a:extLst>
          </p:cNvPr>
          <p:cNvSpPr txBox="1"/>
          <p:nvPr/>
        </p:nvSpPr>
        <p:spPr>
          <a:xfrm>
            <a:off x="10811237" y="3570766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0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5C78C6A-7393-5AFD-8C2D-3A392A9D871E}"/>
              </a:ext>
            </a:extLst>
          </p:cNvPr>
          <p:cNvSpPr txBox="1"/>
          <p:nvPr/>
        </p:nvSpPr>
        <p:spPr>
          <a:xfrm>
            <a:off x="10816165" y="3134323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5 </a:t>
            </a:r>
            <a:r>
              <a:rPr lang="en-GB" dirty="0" err="1"/>
              <a:t>kDa</a:t>
            </a:r>
            <a:endParaRPr lang="en-GB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49E3AF1-C2B0-47B1-79D9-48FBA69C49DD}"/>
              </a:ext>
            </a:extLst>
          </p:cNvPr>
          <p:cNvSpPr/>
          <p:nvPr/>
        </p:nvSpPr>
        <p:spPr>
          <a:xfrm>
            <a:off x="3280060" y="4093148"/>
            <a:ext cx="2039745" cy="5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5EB55F1E-993D-4AAF-49D3-7397B5AF781D}"/>
              </a:ext>
            </a:extLst>
          </p:cNvPr>
          <p:cNvSpPr/>
          <p:nvPr/>
        </p:nvSpPr>
        <p:spPr>
          <a:xfrm>
            <a:off x="8144008" y="2934380"/>
            <a:ext cx="2128996" cy="43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AA5A0C4-A29E-ACE1-805B-FAD4ECA0E702}"/>
              </a:ext>
            </a:extLst>
          </p:cNvPr>
          <p:cNvSpPr/>
          <p:nvPr/>
        </p:nvSpPr>
        <p:spPr>
          <a:xfrm>
            <a:off x="3225447" y="617547"/>
            <a:ext cx="2039745" cy="5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310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8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Ackermann</dc:creator>
  <cp:lastModifiedBy>Tobias Ackermann</cp:lastModifiedBy>
  <cp:revision>3</cp:revision>
  <dcterms:created xsi:type="dcterms:W3CDTF">2023-12-14T20:00:16Z</dcterms:created>
  <dcterms:modified xsi:type="dcterms:W3CDTF">2024-07-16T18:35:20Z</dcterms:modified>
</cp:coreProperties>
</file>